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E22C5-B2D4-4313-8193-C7855A9A9262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B6601-CE96-4C72-BF66-C53A2AE4566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9268374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E22C5-B2D4-4313-8193-C7855A9A9262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B6601-CE96-4C72-BF66-C53A2AE4566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580533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E22C5-B2D4-4313-8193-C7855A9A9262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B6601-CE96-4C72-BF66-C53A2AE4566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5972825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E22C5-B2D4-4313-8193-C7855A9A9262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B6601-CE96-4C72-BF66-C53A2AE4566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8922831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E22C5-B2D4-4313-8193-C7855A9A9262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B6601-CE96-4C72-BF66-C53A2AE4566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44948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E22C5-B2D4-4313-8193-C7855A9A9262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B6601-CE96-4C72-BF66-C53A2AE4566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41493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E22C5-B2D4-4313-8193-C7855A9A9262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B6601-CE96-4C72-BF66-C53A2AE4566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181721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E22C5-B2D4-4313-8193-C7855A9A9262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B6601-CE96-4C72-BF66-C53A2AE4566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002454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E22C5-B2D4-4313-8193-C7855A9A9262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B6601-CE96-4C72-BF66-C53A2AE4566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2546997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E22C5-B2D4-4313-8193-C7855A9A9262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B6601-CE96-4C72-BF66-C53A2AE4566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807494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E22C5-B2D4-4313-8193-C7855A9A9262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B6601-CE96-4C72-BF66-C53A2AE4566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59194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5E22C5-B2D4-4313-8193-C7855A9A9262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5B6601-CE96-4C72-BF66-C53A2AE45667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963123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276" name="Group 60"/>
          <p:cNvGraphicFramePr>
            <a:graphicFrameLocks noGrp="1"/>
          </p:cNvGraphicFramePr>
          <p:nvPr>
            <p:ph idx="1"/>
          </p:nvPr>
        </p:nvGraphicFramePr>
        <p:xfrm>
          <a:off x="611188" y="620713"/>
          <a:ext cx="7489825" cy="3532188"/>
        </p:xfrm>
        <a:graphic>
          <a:graphicData uri="http://schemas.openxmlformats.org/drawingml/2006/table">
            <a:tbl>
              <a:tblPr/>
              <a:tblGrid>
                <a:gridCol w="1223962"/>
                <a:gridCol w="2160588"/>
                <a:gridCol w="2101850"/>
                <a:gridCol w="2003425"/>
              </a:tblGrid>
              <a:tr h="2460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Gene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Forward (5´- 3´) 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Reverse (5´- 3´)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ccession/locus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</a:tr>
              <a:tr h="36512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SlIPT1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ggagatggaggggtatttt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ctcaaccgttggatcttcc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B690812 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36512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SlIPT2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aacgttaacggcgaaaatg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tcacaatcttggcacttgg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B690813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36512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SlIPT3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gcttgctgtcaacgtcaaaa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tccatgcttgatgtgcttc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JF423320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36512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SlIPT6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ctcgagagagattgctgctga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gggatcaccagctttaacca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K324787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36512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SlCKX4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ggtcagcattggagagtggt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ggtccctccattctctttg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B690823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36512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SlCKX5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tcaaatccacgcttttcca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agccatggatgagggacat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B690824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36512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RR1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ggtcagtggtgaaaaccatg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actacgctcttttcgcatc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XM_006345914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36512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RR4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cttgttcgccaacatcacc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gcttaaacgaccccggaagta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XM_006345914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36512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RR12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cctcagggctatggctc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taacttgctagttacaaaaacc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XM_004251717</a:t>
                      </a:r>
                    </a:p>
                  </a:txBody>
                  <a:tcPr marL="9526" marR="9526" marT="9527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</a:tbl>
          </a:graphicData>
        </a:graphic>
      </p:graphicFrame>
      <p:sp>
        <p:nvSpPr>
          <p:cNvPr id="10299" name="Obdélník 5"/>
          <p:cNvSpPr>
            <a:spLocks noChangeArrowheads="1"/>
          </p:cNvSpPr>
          <p:nvPr/>
        </p:nvSpPr>
        <p:spPr bwMode="auto">
          <a:xfrm>
            <a:off x="611188" y="4225925"/>
            <a:ext cx="748982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Additional file 9. Sequences of tomato primers used for qPCR analysis.</a:t>
            </a:r>
          </a:p>
        </p:txBody>
      </p:sp>
    </p:spTree>
    <p:extLst>
      <p:ext uri="{BB962C8B-B14F-4D97-AF65-F5344CB8AC3E}">
        <p14:creationId xmlns:p14="http://schemas.microsoft.com/office/powerpoint/2010/main" val="20752787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</Words>
  <Application>Microsoft Office PowerPoint</Application>
  <PresentationFormat>Předvádění na obrazovce (4:3)</PresentationFormat>
  <Paragraphs>41</Paragraphs>
  <Slides>1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Žižková Eva UEB</dc:creator>
  <cp:lastModifiedBy>Žižková Eva UEB</cp:lastModifiedBy>
  <cp:revision>1</cp:revision>
  <dcterms:created xsi:type="dcterms:W3CDTF">2014-10-10T16:04:48Z</dcterms:created>
  <dcterms:modified xsi:type="dcterms:W3CDTF">2014-10-10T16:05:11Z</dcterms:modified>
</cp:coreProperties>
</file>